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71" r:id="rId2"/>
    <p:sldId id="270" r:id="rId3"/>
    <p:sldId id="269" r:id="rId4"/>
  </p:sldIdLst>
  <p:sldSz cx="5143500" cy="91440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4603" autoAdjust="0"/>
    <p:restoredTop sz="95244" autoAdjust="0"/>
  </p:normalViewPr>
  <p:slideViewPr>
    <p:cSldViewPr snapToGrid="0">
      <p:cViewPr varScale="1">
        <p:scale>
          <a:sx n="86" d="100"/>
          <a:sy n="86" d="100"/>
        </p:scale>
        <p:origin x="3474" y="9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0BB760-1027-4BF3-BA55-93D2D9443987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0B7A9A-EF07-4D17-A27E-85D7FC143E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98419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85763" y="1496484"/>
            <a:ext cx="4371975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42938" y="4802717"/>
            <a:ext cx="3857625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3672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4049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80818" y="486834"/>
            <a:ext cx="1109067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3616" y="486834"/>
            <a:ext cx="3262908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1642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3917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0937" y="2279653"/>
            <a:ext cx="4436269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0937" y="6119286"/>
            <a:ext cx="4436269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/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64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3615" y="2434167"/>
            <a:ext cx="2185988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03897" y="2434167"/>
            <a:ext cx="2185988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8914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4285" y="486836"/>
            <a:ext cx="4436269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4286" y="2241551"/>
            <a:ext cx="2175941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4286" y="3340100"/>
            <a:ext cx="2175941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03897" y="2241551"/>
            <a:ext cx="2186657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03897" y="3340100"/>
            <a:ext cx="2186657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762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9239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3247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4285" y="609600"/>
            <a:ext cx="165891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86657" y="1316569"/>
            <a:ext cx="2603897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4285" y="2743200"/>
            <a:ext cx="165891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6787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4285" y="609600"/>
            <a:ext cx="165891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86657" y="1316569"/>
            <a:ext cx="2603897" cy="6498167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4285" y="2743200"/>
            <a:ext cx="165891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48CDF-8364-410B-B950-2EB10BAA46BB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8596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3616" y="486836"/>
            <a:ext cx="4436269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3616" y="2434167"/>
            <a:ext cx="4436269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3615" y="8475136"/>
            <a:ext cx="1157288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48CDF-8364-410B-B950-2EB10BAA46BB}" type="datetimeFigureOut">
              <a:rPr lang="zh-CN" altLang="en-US" smtClean="0"/>
              <a:t>2021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03785" y="8475136"/>
            <a:ext cx="173593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32597" y="8475136"/>
            <a:ext cx="1157288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7AC89-6C77-41F3-9989-11CDDAB853C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2907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BE55FC94-A379-4BC4-85C7-4209CA430458}"/>
              </a:ext>
            </a:extLst>
          </p:cNvPr>
          <p:cNvSpPr/>
          <p:nvPr/>
        </p:nvSpPr>
        <p:spPr>
          <a:xfrm>
            <a:off x="0" y="4833372"/>
            <a:ext cx="51435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/>
              <a:t>Figure S1. </a:t>
            </a:r>
            <a:r>
              <a:rPr lang="en-US" altLang="zh-CN" sz="1200" dirty="0"/>
              <a:t>Antibody IgM response landscape against SARS-CoV-2 proteins and Spike protein peptides.</a:t>
            </a:r>
            <a:endParaRPr lang="zh-CN" altLang="en-US" sz="1200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A76E925E-CE90-4934-979C-686C9F1E3A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18694"/>
            <a:ext cx="3170042" cy="1585021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835C8306-41F6-466F-BA4E-4CA0EF8BB2A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69243"/>
            <a:ext cx="5143500" cy="1143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8CDF9CAD-9E90-448B-AA8D-C4C1B9BE896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77771"/>
            <a:ext cx="5143500" cy="1143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78977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A4B7DED-9C41-4C0A-9670-034814A6257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1438" b="5882"/>
          <a:stretch/>
        </p:blipFill>
        <p:spPr>
          <a:xfrm>
            <a:off x="614690" y="364719"/>
            <a:ext cx="1626308" cy="142598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949A5AD-0EC7-49A5-8E2E-4B2DC14C9C4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4444" b="6477"/>
          <a:stretch/>
        </p:blipFill>
        <p:spPr>
          <a:xfrm>
            <a:off x="2464728" y="312163"/>
            <a:ext cx="1604016" cy="145313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B22419D-CC95-4979-B5CD-91541E6EE818}"/>
              </a:ext>
            </a:extLst>
          </p:cNvPr>
          <p:cNvSpPr txBox="1"/>
          <p:nvPr/>
        </p:nvSpPr>
        <p:spPr>
          <a:xfrm>
            <a:off x="2464728" y="42356"/>
            <a:ext cx="306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B.</a:t>
            </a:r>
            <a:endParaRPr lang="zh-CN" altLang="en-US" sz="12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B47C2B6-E49E-4709-8E1A-36A598C16401}"/>
              </a:ext>
            </a:extLst>
          </p:cNvPr>
          <p:cNvSpPr txBox="1"/>
          <p:nvPr/>
        </p:nvSpPr>
        <p:spPr>
          <a:xfrm>
            <a:off x="563917" y="62495"/>
            <a:ext cx="3138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A.</a:t>
            </a:r>
            <a:endParaRPr lang="zh-CN" altLang="en-US" sz="1200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44660F9D-5DCA-4C6B-9530-D0E705D8AE0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" r="24814" b="6462"/>
          <a:stretch/>
        </p:blipFill>
        <p:spPr>
          <a:xfrm>
            <a:off x="627192" y="2167633"/>
            <a:ext cx="1646817" cy="1499492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8DCDC07-9C0D-4F27-8690-739B06C5380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5803" b="6172"/>
          <a:stretch/>
        </p:blipFill>
        <p:spPr>
          <a:xfrm>
            <a:off x="2629136" y="2107880"/>
            <a:ext cx="1678793" cy="1553781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9ECB00EF-A26C-4659-AF35-D514C347C114}"/>
              </a:ext>
            </a:extLst>
          </p:cNvPr>
          <p:cNvSpPr txBox="1"/>
          <p:nvPr/>
        </p:nvSpPr>
        <p:spPr>
          <a:xfrm>
            <a:off x="527705" y="1897992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C.</a:t>
            </a:r>
            <a:endParaRPr lang="zh-CN" altLang="en-US" sz="12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9F1D6F6-A198-4857-B474-FC35B53846A9}"/>
              </a:ext>
            </a:extLst>
          </p:cNvPr>
          <p:cNvSpPr txBox="1"/>
          <p:nvPr/>
        </p:nvSpPr>
        <p:spPr>
          <a:xfrm>
            <a:off x="2513248" y="1872215"/>
            <a:ext cx="3141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D.</a:t>
            </a:r>
            <a:endParaRPr lang="zh-CN" altLang="en-US" sz="1200" dirty="0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21480450-2ECE-4460-B8C1-89AF486BD4DC}"/>
              </a:ext>
            </a:extLst>
          </p:cNvPr>
          <p:cNvSpPr/>
          <p:nvPr/>
        </p:nvSpPr>
        <p:spPr>
          <a:xfrm>
            <a:off x="-107022" y="3913183"/>
            <a:ext cx="51435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/>
              <a:t>Figure S2. The antibody dynamic response of S1, N proteins.</a:t>
            </a:r>
            <a:endParaRPr lang="zh-CN" altLang="en-US" sz="12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E8C942D-1C91-4A62-BD36-A4ACED674E97}"/>
              </a:ext>
            </a:extLst>
          </p:cNvPr>
          <p:cNvSpPr txBox="1"/>
          <p:nvPr/>
        </p:nvSpPr>
        <p:spPr>
          <a:xfrm>
            <a:off x="985104" y="3620708"/>
            <a:ext cx="13003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/>
              <a:t>Days after onset of symptoms</a:t>
            </a:r>
            <a:endParaRPr lang="zh-CN" altLang="en-US" sz="700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C7CF777-4EAB-4F6A-8DCC-277E65F9CD6A}"/>
              </a:ext>
            </a:extLst>
          </p:cNvPr>
          <p:cNvSpPr txBox="1"/>
          <p:nvPr/>
        </p:nvSpPr>
        <p:spPr>
          <a:xfrm>
            <a:off x="2813591" y="1721663"/>
            <a:ext cx="13003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/>
              <a:t>Days after onset of symptoms</a:t>
            </a:r>
            <a:endParaRPr lang="zh-CN" altLang="en-US" sz="700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49184D0-651D-4286-85DF-B33D0AAD5977}"/>
              </a:ext>
            </a:extLst>
          </p:cNvPr>
          <p:cNvSpPr txBox="1"/>
          <p:nvPr/>
        </p:nvSpPr>
        <p:spPr>
          <a:xfrm>
            <a:off x="940642" y="1736883"/>
            <a:ext cx="13003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/>
              <a:t>Days after onset of symptoms</a:t>
            </a:r>
            <a:endParaRPr lang="zh-CN" altLang="en-US" sz="7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4C356ED-13E3-444A-9C5F-542E791C3382}"/>
              </a:ext>
            </a:extLst>
          </p:cNvPr>
          <p:cNvSpPr txBox="1"/>
          <p:nvPr/>
        </p:nvSpPr>
        <p:spPr>
          <a:xfrm>
            <a:off x="2969260" y="3620707"/>
            <a:ext cx="13003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/>
              <a:t>Days after onset of symptoms</a:t>
            </a:r>
            <a:endParaRPr lang="zh-CN" altLang="en-US" sz="700" b="1" dirty="0"/>
          </a:p>
        </p:txBody>
      </p:sp>
    </p:spTree>
    <p:extLst>
      <p:ext uri="{BB962C8B-B14F-4D97-AF65-F5344CB8AC3E}">
        <p14:creationId xmlns:p14="http://schemas.microsoft.com/office/powerpoint/2010/main" val="20120126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>
            <a:extLst>
              <a:ext uri="{FF2B5EF4-FFF2-40B4-BE49-F238E27FC236}">
                <a16:creationId xmlns:a16="http://schemas.microsoft.com/office/drawing/2014/main" id="{E709A97C-1784-4C16-AFB9-C787D6C5A5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306" y="726170"/>
            <a:ext cx="500519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 S1.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tudies of COVID-19 serum profiling.</a:t>
            </a:r>
            <a:endParaRPr kumimoji="0" lang="en-US" altLang="zh-CN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F371F86D-83F3-4C81-BCA4-BF8AE363D1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0379029"/>
              </p:ext>
            </p:extLst>
          </p:nvPr>
        </p:nvGraphicFramePr>
        <p:xfrm>
          <a:off x="270509" y="1049336"/>
          <a:ext cx="4602481" cy="2539539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632460">
                  <a:extLst>
                    <a:ext uri="{9D8B030D-6E8A-4147-A177-3AD203B41FA5}">
                      <a16:colId xmlns:a16="http://schemas.microsoft.com/office/drawing/2014/main" val="1328518106"/>
                    </a:ext>
                  </a:extLst>
                </a:gridCol>
                <a:gridCol w="583883">
                  <a:extLst>
                    <a:ext uri="{9D8B030D-6E8A-4147-A177-3AD203B41FA5}">
                      <a16:colId xmlns:a16="http://schemas.microsoft.com/office/drawing/2014/main" val="3549637632"/>
                    </a:ext>
                  </a:extLst>
                </a:gridCol>
                <a:gridCol w="1665923">
                  <a:extLst>
                    <a:ext uri="{9D8B030D-6E8A-4147-A177-3AD203B41FA5}">
                      <a16:colId xmlns:a16="http://schemas.microsoft.com/office/drawing/2014/main" val="24235904"/>
                    </a:ext>
                  </a:extLst>
                </a:gridCol>
                <a:gridCol w="528638">
                  <a:extLst>
                    <a:ext uri="{9D8B030D-6E8A-4147-A177-3AD203B41FA5}">
                      <a16:colId xmlns:a16="http://schemas.microsoft.com/office/drawing/2014/main" val="3756159415"/>
                    </a:ext>
                  </a:extLst>
                </a:gridCol>
                <a:gridCol w="620076">
                  <a:extLst>
                    <a:ext uri="{9D8B030D-6E8A-4147-A177-3AD203B41FA5}">
                      <a16:colId xmlns:a16="http://schemas.microsoft.com/office/drawing/2014/main" val="3091461636"/>
                    </a:ext>
                  </a:extLst>
                </a:gridCol>
                <a:gridCol w="571501">
                  <a:extLst>
                    <a:ext uri="{9D8B030D-6E8A-4147-A177-3AD203B41FA5}">
                      <a16:colId xmlns:a16="http://schemas.microsoft.com/office/drawing/2014/main" val="2065560456"/>
                    </a:ext>
                  </a:extLst>
                </a:gridCol>
              </a:tblGrid>
              <a:tr h="301859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Projec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Serum </a:t>
                      </a:r>
                    </a:p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sample (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Proteome coverag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Antigen typ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Technology platfor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Sympto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2616001"/>
                  </a:ext>
                </a:extLst>
              </a:tr>
              <a:tr h="29569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>
                          <a:effectLst/>
                        </a:rPr>
                        <a:t>This stud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900" u="none" strike="noStrike" dirty="0">
                          <a:effectLst/>
                        </a:rPr>
                        <a:t>2360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21/28 predicted viral proteins, peptides of Spike prote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Protein, peptid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>
                          <a:effectLst/>
                        </a:rPr>
                        <a:t>Protein microarra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>
                          <a:effectLst/>
                        </a:rPr>
                        <a:t>Mild, Severe, Critic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882268593"/>
                  </a:ext>
                </a:extLst>
              </a:tr>
              <a:tr h="19713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 err="1">
                          <a:effectLst/>
                        </a:rPr>
                        <a:t>Shrock</a:t>
                      </a:r>
                      <a:r>
                        <a:rPr lang="en-US" sz="900" u="none" strike="noStrike" dirty="0">
                          <a:effectLst/>
                        </a:rPr>
                        <a:t> </a:t>
                      </a:r>
                      <a:r>
                        <a:rPr lang="en-US" sz="900" i="1" u="none" strike="noStrike" dirty="0">
                          <a:effectLst/>
                        </a:rPr>
                        <a:t>et.al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900" u="none" strike="noStrike" dirty="0">
                          <a:effectLst/>
                        </a:rPr>
                        <a:t>232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Full proteome of SARS-CoV-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peptid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Phage displa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Not indicate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71657172"/>
                  </a:ext>
                </a:extLst>
              </a:tr>
              <a:tr h="19713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Wang </a:t>
                      </a:r>
                      <a:r>
                        <a:rPr lang="en-US" sz="900" i="1" u="none" strike="noStrike" dirty="0">
                          <a:effectLst/>
                        </a:rPr>
                        <a:t>et.al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900" u="none" strike="noStrike" dirty="0">
                          <a:effectLst/>
                        </a:rPr>
                        <a:t>10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900" u="none" strike="noStrike" dirty="0">
                          <a:effectLst/>
                        </a:rPr>
                        <a:t>SARS-CoV-2 N, E, S proteins</a:t>
                      </a:r>
                      <a:endParaRPr lang="pt-B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peptid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Peptide microarra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Mil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extLst>
                  <a:ext uri="{0D108BD9-81ED-4DB2-BD59-A6C34878D82A}">
                    <a16:rowId xmlns:a16="http://schemas.microsoft.com/office/drawing/2014/main" val="2707938467"/>
                  </a:ext>
                </a:extLst>
              </a:tr>
              <a:tr h="19713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Schwarz </a:t>
                      </a:r>
                      <a:r>
                        <a:rPr lang="en-US" sz="900" i="1" u="none" strike="noStrike" dirty="0">
                          <a:effectLst/>
                        </a:rPr>
                        <a:t>et.al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900" u="none" strike="noStrike" dirty="0">
                          <a:effectLst/>
                        </a:rPr>
                        <a:t>16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SARS-CoV-2 ORF1a/b, ORF3a, S, E, M, ORF6, ORF7a, ORF8, N and ORF10 protein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peptid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Peptide microarra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Mild, Sever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5522426"/>
                  </a:ext>
                </a:extLst>
              </a:tr>
              <a:tr h="19713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 err="1">
                          <a:effectLst/>
                        </a:rPr>
                        <a:t>Hokenya</a:t>
                      </a:r>
                      <a:r>
                        <a:rPr lang="en-US" sz="900" u="none" strike="noStrike" dirty="0">
                          <a:effectLst/>
                        </a:rPr>
                        <a:t> </a:t>
                      </a:r>
                      <a:r>
                        <a:rPr lang="en-US" sz="900" i="1" u="none" strike="noStrike" dirty="0">
                          <a:effectLst/>
                        </a:rPr>
                        <a:t>et.al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900" u="none" strike="noStrike" dirty="0">
                          <a:effectLst/>
                        </a:rPr>
                        <a:t>24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>
                          <a:effectLst/>
                        </a:rPr>
                        <a:t>Full proteome of SARS-CoV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>
                          <a:effectLst/>
                        </a:rPr>
                        <a:t>peptid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>
                          <a:effectLst/>
                        </a:rPr>
                        <a:t>Peptide microarra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Mild, Sever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extLst>
                  <a:ext uri="{0D108BD9-81ED-4DB2-BD59-A6C34878D82A}">
                    <a16:rowId xmlns:a16="http://schemas.microsoft.com/office/drawing/2014/main" val="1014850481"/>
                  </a:ext>
                </a:extLst>
              </a:tr>
              <a:tr h="19713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Wu </a:t>
                      </a:r>
                      <a:r>
                        <a:rPr lang="en-US" sz="900" i="1" u="none" strike="noStrike" dirty="0">
                          <a:effectLst/>
                        </a:rPr>
                        <a:t>et.al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900" u="none" strike="noStrike" dirty="0">
                          <a:effectLst/>
                        </a:rPr>
                        <a:t>585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SARS-CoV-2 S, N protein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Prote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CLIA 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Mild, Sever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5371772"/>
                  </a:ext>
                </a:extLst>
              </a:tr>
              <a:tr h="19713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Assis </a:t>
                      </a:r>
                      <a:r>
                        <a:rPr lang="en-US" sz="900" i="1" u="none" strike="noStrike" dirty="0">
                          <a:effectLst/>
                        </a:rPr>
                        <a:t>et.al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900" u="none" strike="noStrike" dirty="0">
                          <a:effectLst/>
                        </a:rPr>
                        <a:t>135</a:t>
                      </a:r>
                      <a:endParaRPr lang="en-US" altLang="zh-CN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SARS-CoV-2 S, N protein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>
                          <a:effectLst/>
                        </a:rPr>
                        <a:t>Prote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>
                          <a:effectLst/>
                        </a:rPr>
                        <a:t>Protein microarra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900" u="none" strike="noStrike" dirty="0">
                          <a:effectLst/>
                        </a:rPr>
                        <a:t>Not indicate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等线" panose="02010600030101010101" pitchFamily="2" charset="-122"/>
                      </a:endParaRPr>
                    </a:p>
                  </a:txBody>
                  <a:tcPr marL="6160" marR="6160" marT="6160" marB="0" anchor="ctr"/>
                </a:tc>
                <a:extLst>
                  <a:ext uri="{0D108BD9-81ED-4DB2-BD59-A6C34878D82A}">
                    <a16:rowId xmlns:a16="http://schemas.microsoft.com/office/drawing/2014/main" val="37583576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97434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82</TotalTime>
  <Words>205</Words>
  <Application>Microsoft Office PowerPoint</Application>
  <PresentationFormat>全屏显示(16:9)</PresentationFormat>
  <Paragraphs>6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ZW</dc:creator>
  <cp:lastModifiedBy>XZW</cp:lastModifiedBy>
  <cp:revision>124</cp:revision>
  <dcterms:created xsi:type="dcterms:W3CDTF">2020-09-25T01:15:47Z</dcterms:created>
  <dcterms:modified xsi:type="dcterms:W3CDTF">2021-07-14T09:21:59Z</dcterms:modified>
</cp:coreProperties>
</file>